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120" d="100"/>
          <a:sy n="120" d="100"/>
        </p:scale>
        <p:origin x="120" y="2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Alcím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u-HU" smtClean="0"/>
              <a:t>Kattintson ide az alcím mintájának szerkesztéséhez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766567-712F-4D85-8FCF-9C5E4A5E4069}" type="datetimeFigureOut">
              <a:rPr lang="hu-HU" smtClean="0"/>
              <a:t>2021. 08. 23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E6777-A3CE-4F61-8150-73AB3814130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108018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766567-712F-4D85-8FCF-9C5E4A5E4069}" type="datetimeFigureOut">
              <a:rPr lang="hu-HU" smtClean="0"/>
              <a:t>2021. 08. 23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E6777-A3CE-4F61-8150-73AB3814130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0927927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766567-712F-4D85-8FCF-9C5E4A5E4069}" type="datetimeFigureOut">
              <a:rPr lang="hu-HU" smtClean="0"/>
              <a:t>2021. 08. 23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E6777-A3CE-4F61-8150-73AB3814130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3883933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766567-712F-4D85-8FCF-9C5E4A5E4069}" type="datetimeFigureOut">
              <a:rPr lang="hu-HU" smtClean="0"/>
              <a:t>2021. 08. 23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E6777-A3CE-4F61-8150-73AB3814130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5599517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766567-712F-4D85-8FCF-9C5E4A5E4069}" type="datetimeFigureOut">
              <a:rPr lang="hu-HU" smtClean="0"/>
              <a:t>2021. 08. 23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E6777-A3CE-4F61-8150-73AB3814130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1159440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Tartalom helye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766567-712F-4D85-8FCF-9C5E4A5E4069}" type="datetimeFigureOut">
              <a:rPr lang="hu-HU" smtClean="0"/>
              <a:t>2021. 08. 23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E6777-A3CE-4F61-8150-73AB3814130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8150134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5" name="Szöveg hely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6" name="Tartalom helye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7" name="Dátum hely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766567-712F-4D85-8FCF-9C5E4A5E4069}" type="datetimeFigureOut">
              <a:rPr lang="hu-HU" smtClean="0"/>
              <a:t>2021. 08. 23.</a:t>
            </a:fld>
            <a:endParaRPr lang="hu-HU"/>
          </a:p>
        </p:txBody>
      </p:sp>
      <p:sp>
        <p:nvSpPr>
          <p:cNvPr id="8" name="Élőláb hely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Dia számának hely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E6777-A3CE-4F61-8150-73AB3814130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8848301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Dátum hely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766567-712F-4D85-8FCF-9C5E4A5E4069}" type="datetimeFigureOut">
              <a:rPr lang="hu-HU" smtClean="0"/>
              <a:t>2021. 08. 23.</a:t>
            </a:fld>
            <a:endParaRPr lang="hu-HU"/>
          </a:p>
        </p:txBody>
      </p:sp>
      <p:sp>
        <p:nvSpPr>
          <p:cNvPr id="4" name="Élőláb hely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Dia számának hely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E6777-A3CE-4F61-8150-73AB3814130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7889119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átum hely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766567-712F-4D85-8FCF-9C5E4A5E4069}" type="datetimeFigureOut">
              <a:rPr lang="hu-HU" smtClean="0"/>
              <a:t>2021. 08. 23.</a:t>
            </a:fld>
            <a:endParaRPr lang="hu-HU"/>
          </a:p>
        </p:txBody>
      </p:sp>
      <p:sp>
        <p:nvSpPr>
          <p:cNvPr id="3" name="Élőláb hely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Dia számának hely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E6777-A3CE-4F61-8150-73AB3814130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6442678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766567-712F-4D85-8FCF-9C5E4A5E4069}" type="datetimeFigureOut">
              <a:rPr lang="hu-HU" smtClean="0"/>
              <a:t>2021. 08. 23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E6777-A3CE-4F61-8150-73AB3814130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7348844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Kép hely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u-HU"/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766567-712F-4D85-8FCF-9C5E4A5E4069}" type="datetimeFigureOut">
              <a:rPr lang="hu-HU" smtClean="0"/>
              <a:t>2021. 08. 23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E6777-A3CE-4F61-8150-73AB3814130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910719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hely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766567-712F-4D85-8FCF-9C5E4A5E4069}" type="datetimeFigureOut">
              <a:rPr lang="hu-HU" smtClean="0"/>
              <a:t>2021. 08. 23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5E6777-A3CE-4F61-8150-73AB3814130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0142838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u-H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Kép 3"/>
          <p:cNvPicPr>
            <a:picLocks noChangeAspect="1"/>
          </p:cNvPicPr>
          <p:nvPr/>
        </p:nvPicPr>
        <p:blipFill rotWithShape="1">
          <a:blip r:embed="rId2"/>
          <a:srcRect l="206"/>
          <a:stretch/>
        </p:blipFill>
        <p:spPr>
          <a:xfrm>
            <a:off x="1916263" y="818985"/>
            <a:ext cx="8217987" cy="2622304"/>
          </a:xfrm>
          <a:prstGeom prst="rect">
            <a:avLst/>
          </a:prstGeom>
        </p:spPr>
      </p:pic>
      <p:sp>
        <p:nvSpPr>
          <p:cNvPr id="5" name="Téglalap 4"/>
          <p:cNvSpPr/>
          <p:nvPr/>
        </p:nvSpPr>
        <p:spPr>
          <a:xfrm>
            <a:off x="4142629" y="1932168"/>
            <a:ext cx="95416" cy="556591"/>
          </a:xfrm>
          <a:prstGeom prst="rect">
            <a:avLst/>
          </a:prstGeom>
          <a:noFill/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/>
          </a:p>
        </p:txBody>
      </p:sp>
      <p:sp>
        <p:nvSpPr>
          <p:cNvPr id="6" name="Téglalap 5"/>
          <p:cNvSpPr/>
          <p:nvPr/>
        </p:nvSpPr>
        <p:spPr>
          <a:xfrm>
            <a:off x="7983107" y="1995778"/>
            <a:ext cx="119272" cy="238539"/>
          </a:xfrm>
          <a:prstGeom prst="rect">
            <a:avLst/>
          </a:prstGeom>
          <a:noFill/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/>
          </a:p>
        </p:txBody>
      </p:sp>
      <p:sp>
        <p:nvSpPr>
          <p:cNvPr id="7" name="Téglalap 6"/>
          <p:cNvSpPr/>
          <p:nvPr/>
        </p:nvSpPr>
        <p:spPr>
          <a:xfrm>
            <a:off x="9827813" y="1979876"/>
            <a:ext cx="95416" cy="238539"/>
          </a:xfrm>
          <a:prstGeom prst="rect">
            <a:avLst/>
          </a:prstGeom>
          <a:noFill/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/>
          </a:p>
        </p:txBody>
      </p:sp>
      <p:sp>
        <p:nvSpPr>
          <p:cNvPr id="8" name="Téglalap 7"/>
          <p:cNvSpPr/>
          <p:nvPr/>
        </p:nvSpPr>
        <p:spPr>
          <a:xfrm>
            <a:off x="2735246" y="2937194"/>
            <a:ext cx="119272" cy="238539"/>
          </a:xfrm>
          <a:prstGeom prst="rect">
            <a:avLst/>
          </a:prstGeom>
          <a:noFill/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/>
          </a:p>
        </p:txBody>
      </p:sp>
      <p:sp>
        <p:nvSpPr>
          <p:cNvPr id="9" name="Téglalap 8"/>
          <p:cNvSpPr/>
          <p:nvPr/>
        </p:nvSpPr>
        <p:spPr>
          <a:xfrm>
            <a:off x="2918126" y="1335820"/>
            <a:ext cx="119272" cy="2385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/>
          </a:p>
        </p:txBody>
      </p:sp>
      <p:sp>
        <p:nvSpPr>
          <p:cNvPr id="11" name="Téglalap 10"/>
          <p:cNvSpPr/>
          <p:nvPr/>
        </p:nvSpPr>
        <p:spPr>
          <a:xfrm>
            <a:off x="9947081" y="1979876"/>
            <a:ext cx="95416" cy="508883"/>
          </a:xfrm>
          <a:prstGeom prst="rect">
            <a:avLst/>
          </a:prstGeom>
          <a:noFill/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/>
          </a:p>
        </p:txBody>
      </p:sp>
      <p:sp>
        <p:nvSpPr>
          <p:cNvPr id="12" name="Téglalap 11"/>
          <p:cNvSpPr/>
          <p:nvPr/>
        </p:nvSpPr>
        <p:spPr>
          <a:xfrm>
            <a:off x="9374585" y="2258171"/>
            <a:ext cx="119272" cy="2385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/>
          </a:p>
        </p:txBody>
      </p:sp>
      <p:sp>
        <p:nvSpPr>
          <p:cNvPr id="13" name="Téglalap 12"/>
          <p:cNvSpPr/>
          <p:nvPr/>
        </p:nvSpPr>
        <p:spPr>
          <a:xfrm>
            <a:off x="5772646" y="3175733"/>
            <a:ext cx="103367" cy="2385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/>
          </a:p>
        </p:txBody>
      </p:sp>
      <p:sp>
        <p:nvSpPr>
          <p:cNvPr id="20" name="Szövegdoboz 19"/>
          <p:cNvSpPr txBox="1"/>
          <p:nvPr/>
        </p:nvSpPr>
        <p:spPr>
          <a:xfrm>
            <a:off x="1606163" y="4018700"/>
            <a:ext cx="8658971" cy="14157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200" smtClean="0"/>
              <a:t>Figure S2. Comparison </a:t>
            </a:r>
            <a:r>
              <a:rPr lang="hu-HU" sz="1200" smtClean="0"/>
              <a:t>of sites in vitro phosphorylated by the RBK1 kinase in barley HvRACB GTPase (Weiß et al.  2020) and by the CPK17 kinase in Arabidopsis AtROP1 (this study). </a:t>
            </a:r>
          </a:p>
          <a:p>
            <a:r>
              <a:rPr lang="hu-HU" sz="1200" smtClean="0"/>
              <a:t>Sites phosphorylated only by RBK1 are boxed in blue, only by CPK17 in red, by both in green.</a:t>
            </a:r>
          </a:p>
          <a:p>
            <a:endParaRPr lang="hu-HU" sz="1400"/>
          </a:p>
          <a:p>
            <a:r>
              <a:rPr lang="hu-HU" sz="1200" smtClean="0">
                <a:effectLst/>
              </a:rPr>
              <a:t>Weiß, L., Reiner, T., Mergner, J., Kuster, B., Fehér, A., Hensel, G., Gahrtz, M., Kumlehn, J., Engelhardt, S., and Hückelhoven, R. (2020). Posttranslational modification of the RHO of plants protein RACB by phosphorylation and cross-kingdom conserved ubiquitination. BioRxiv 2020.05.28.121228.</a:t>
            </a:r>
          </a:p>
        </p:txBody>
      </p:sp>
    </p:spTree>
    <p:extLst>
      <p:ext uri="{BB962C8B-B14F-4D97-AF65-F5344CB8AC3E}">
        <p14:creationId xmlns:p14="http://schemas.microsoft.com/office/powerpoint/2010/main" val="32902013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120</Words>
  <Application>Microsoft Office PowerPoint</Application>
  <PresentationFormat>Szélesvásznú</PresentationFormat>
  <Paragraphs>4</Paragraphs>
  <Slides>1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3</vt:i4>
      </vt:variant>
      <vt:variant>
        <vt:lpstr>Téma</vt:lpstr>
      </vt:variant>
      <vt:variant>
        <vt:i4>1</vt:i4>
      </vt:variant>
      <vt:variant>
        <vt:lpstr>Diacímek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éma</vt:lpstr>
      <vt:lpstr>PowerPoint-bemutat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bemutató</dc:title>
  <dc:creator>Attila Sándor Fehér</dc:creator>
  <cp:lastModifiedBy>Attila Sándor Fehér</cp:lastModifiedBy>
  <cp:revision>4</cp:revision>
  <dcterms:created xsi:type="dcterms:W3CDTF">2021-07-19T06:44:48Z</dcterms:created>
  <dcterms:modified xsi:type="dcterms:W3CDTF">2021-08-23T09:12:54Z</dcterms:modified>
</cp:coreProperties>
</file>